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4"/>
  </p:notesMasterIdLst>
  <p:sldIdLst>
    <p:sldId id="276" r:id="rId2"/>
    <p:sldId id="275" r:id="rId3"/>
  </p:sldIdLst>
  <p:sldSz cx="9144000" cy="6858000" type="screen4x3"/>
  <p:notesSz cx="9236075" cy="695007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1390" autoAdjust="0"/>
    <p:restoredTop sz="94660"/>
  </p:normalViewPr>
  <p:slideViewPr>
    <p:cSldViewPr snapToGrid="0">
      <p:cViewPr>
        <p:scale>
          <a:sx n="50" d="100"/>
          <a:sy n="50" d="100"/>
        </p:scale>
        <p:origin x="1832" y="2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4002299" cy="349113"/>
          </a:xfrm>
          <a:prstGeom prst="rect">
            <a:avLst/>
          </a:prstGeom>
        </p:spPr>
        <p:txBody>
          <a:bodyPr vert="horz" lIns="92492" tIns="46246" rIns="92492" bIns="46246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5232173" y="0"/>
            <a:ext cx="4002299" cy="349113"/>
          </a:xfrm>
          <a:prstGeom prst="rect">
            <a:avLst/>
          </a:prstGeom>
        </p:spPr>
        <p:txBody>
          <a:bodyPr vert="horz" lIns="92492" tIns="46246" rIns="92492" bIns="46246" rtlCol="0"/>
          <a:lstStyle>
            <a:lvl1pPr algn="r">
              <a:defRPr sz="1200"/>
            </a:lvl1pPr>
          </a:lstStyle>
          <a:p>
            <a:fld id="{33A89985-5F55-4F6C-80AD-01975FDB17CD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054350" y="868363"/>
            <a:ext cx="3127375" cy="23463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492" tIns="46246" rIns="92492" bIns="46246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923608" y="3344724"/>
            <a:ext cx="7388860" cy="2736592"/>
          </a:xfrm>
          <a:prstGeom prst="rect">
            <a:avLst/>
          </a:prstGeom>
        </p:spPr>
        <p:txBody>
          <a:bodyPr vert="horz" lIns="92492" tIns="46246" rIns="92492" bIns="46246" rtlCol="0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6600963"/>
            <a:ext cx="4002299" cy="349112"/>
          </a:xfrm>
          <a:prstGeom prst="rect">
            <a:avLst/>
          </a:prstGeom>
        </p:spPr>
        <p:txBody>
          <a:bodyPr vert="horz" lIns="92492" tIns="46246" rIns="92492" bIns="46246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5232173" y="6600963"/>
            <a:ext cx="4002299" cy="349112"/>
          </a:xfrm>
          <a:prstGeom prst="rect">
            <a:avLst/>
          </a:prstGeom>
        </p:spPr>
        <p:txBody>
          <a:bodyPr vert="horz" lIns="92492" tIns="46246" rIns="92492" bIns="46246" rtlCol="0" anchor="b"/>
          <a:lstStyle>
            <a:lvl1pPr algn="r">
              <a:defRPr sz="1200"/>
            </a:lvl1pPr>
          </a:lstStyle>
          <a:p>
            <a:fld id="{8CFC65A9-B369-427F-8795-699D7426D68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53756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FC65A9-B369-427F-8795-699D7426D680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787553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25AB6-36DF-4E49-BD97-FA82359D4CD0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B66DF-1D4B-4BEE-803A-00720213FB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477148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25AB6-36DF-4E49-BD97-FA82359D4CD0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B66DF-1D4B-4BEE-803A-00720213FB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18799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25AB6-36DF-4E49-BD97-FA82359D4CD0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B66DF-1D4B-4BEE-803A-00720213FB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55187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25AB6-36DF-4E49-BD97-FA82359D4CD0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B66DF-1D4B-4BEE-803A-00720213FB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861699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25AB6-36DF-4E49-BD97-FA82359D4CD0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B66DF-1D4B-4BEE-803A-00720213FB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370626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25AB6-36DF-4E49-BD97-FA82359D4CD0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B66DF-1D4B-4BEE-803A-00720213FB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34770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25AB6-36DF-4E49-BD97-FA82359D4CD0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B66DF-1D4B-4BEE-803A-00720213FB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57963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25AB6-36DF-4E49-BD97-FA82359D4CD0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B66DF-1D4B-4BEE-803A-00720213FB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28372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25AB6-36DF-4E49-BD97-FA82359D4CD0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B66DF-1D4B-4BEE-803A-00720213FB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327804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25AB6-36DF-4E49-BD97-FA82359D4CD0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B66DF-1D4B-4BEE-803A-00720213FB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1555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4125AB6-36DF-4E49-BD97-FA82359D4CD0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B8B66DF-1D4B-4BEE-803A-00720213FB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104653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4125AB6-36DF-4E49-BD97-FA82359D4CD0}" type="datetimeFigureOut">
              <a:rPr lang="en-US" smtClean="0"/>
              <a:t>11/20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B8B66DF-1D4B-4BEE-803A-00720213FB0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1265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48455038"/>
              </p:ext>
            </p:extLst>
          </p:nvPr>
        </p:nvGraphicFramePr>
        <p:xfrm>
          <a:off x="1906588" y="504825"/>
          <a:ext cx="5148262" cy="395128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279" name="Prism 6" r:id="rId4" imgW="3713719" imgH="2849539" progId="Prism6.Document">
                  <p:embed/>
                </p:oleObj>
              </mc:Choice>
              <mc:Fallback>
                <p:oleObj name="Prism 6" r:id="rId4" imgW="3713719" imgH="2849539" progId="Prism6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906588" y="504825"/>
                        <a:ext cx="5148262" cy="395128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" name="TextBox 2"/>
          <p:cNvSpPr txBox="1"/>
          <p:nvPr/>
        </p:nvSpPr>
        <p:spPr>
          <a:xfrm>
            <a:off x="262566" y="4633913"/>
            <a:ext cx="8640134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1. Correlation between IgG and IgG4 levels in COVID-19 vaccinees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BD-specific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gG and IgG4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were analyzed in serum samples after two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imary doses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two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booster mRNA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oses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t four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 time intervals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tatistical analysis was perform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using Spearman.</a:t>
            </a:r>
            <a:endParaRPr lang="en-US" sz="12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2166843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FF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Objec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85179297"/>
              </p:ext>
            </p:extLst>
          </p:nvPr>
        </p:nvGraphicFramePr>
        <p:xfrm>
          <a:off x="577370" y="596900"/>
          <a:ext cx="8010525" cy="36115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52" name="Prism 6" r:id="rId3" imgW="8010139" imgH="3611985" progId="Prism6.Document">
                  <p:embed/>
                </p:oleObj>
              </mc:Choice>
              <mc:Fallback>
                <p:oleObj name="Prism 6" r:id="rId3" imgW="8010139" imgH="3611985" progId="Prism6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77370" y="596900"/>
                        <a:ext cx="8010525" cy="36115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262566" y="4633913"/>
            <a:ext cx="8640134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. IL-10 cytokine levels after COVID-19 vaccination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rum IL-10 cytokines levels were determin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in participants who received (A) four doses of mRNA (n=10) and (B) two primary Covishield and two booster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OVID-19 vaccin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RNA vaccines (n=19). Fold rises (post </a:t>
            </a:r>
            <a:r>
              <a:rPr lang="en-US" sz="1200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vs.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evaccination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) of IL-10 were measured after each vaccine dose. Bars showing </a:t>
            </a:r>
            <a:r>
              <a:rPr lang="en-US" sz="1200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mean+SEM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of IL-10 fold rise. 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2666591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407</TotalTime>
  <Words>119</Words>
  <Application>Microsoft Office PowerPoint</Application>
  <PresentationFormat>On-screen Show (4:3)</PresentationFormat>
  <Paragraphs>3</Paragraphs>
  <Slides>2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Times New Roman</vt:lpstr>
      <vt:lpstr>Office Theme</vt:lpstr>
      <vt:lpstr>GraphPad Prism 6 Project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jahan Akhtar</dc:creator>
  <cp:lastModifiedBy>Marjahan Akhtar</cp:lastModifiedBy>
  <cp:revision>225</cp:revision>
  <cp:lastPrinted>2023-08-14T07:44:03Z</cp:lastPrinted>
  <dcterms:created xsi:type="dcterms:W3CDTF">2023-05-31T06:58:09Z</dcterms:created>
  <dcterms:modified xsi:type="dcterms:W3CDTF">2023-11-20T09:33:43Z</dcterms:modified>
</cp:coreProperties>
</file>